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975350" cy="27003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D9863-A838-4047-A908-B5348B95C0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98080" y="631800"/>
            <a:ext cx="538020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98080" y="1562400"/>
            <a:ext cx="538020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5445F-CA8B-4D5A-833C-75BC74788C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98080" y="6318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055320" y="6318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98080" y="15624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055320" y="15624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D82849-37CC-42DC-83C5-3C05AB7543C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98080" y="631800"/>
            <a:ext cx="173232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17520" y="631800"/>
            <a:ext cx="173232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936600" y="631800"/>
            <a:ext cx="173232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98080" y="1562400"/>
            <a:ext cx="173232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17520" y="1562400"/>
            <a:ext cx="173232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936600" y="1562400"/>
            <a:ext cx="173232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1FA98-6381-4856-8C11-9DCD1581DF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98080" y="631800"/>
            <a:ext cx="5380200" cy="178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25"/>
              </a:spcBef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BD307-1670-4199-80F0-EAE9A79D66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98080" y="631800"/>
            <a:ext cx="5380200" cy="178128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EB59E-9664-47D5-ACF5-F9052E2270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98080" y="631800"/>
            <a:ext cx="2625480" cy="178128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055320" y="631800"/>
            <a:ext cx="2625480" cy="178128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493601-1FBF-4BC8-A48A-F93BC3684B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177B24-81E7-49EF-86E3-0AB223D4EA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98080" y="109080"/>
            <a:ext cx="5380200" cy="20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25"/>
              </a:spcBef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AF68F-6A04-49B0-8947-7AC332DDBA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98080" y="6318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055320" y="631800"/>
            <a:ext cx="2625480" cy="178128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98080" y="15624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3C617-F0FC-4819-ADC0-44F7885C45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98080" y="631800"/>
            <a:ext cx="2625480" cy="178128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055320" y="6318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055320" y="15624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79D53-C5BB-401E-9460-B69CEA8C65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98080" y="6318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055320" y="631800"/>
            <a:ext cx="262548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98080" y="1562400"/>
            <a:ext cx="5380200" cy="8496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6D0A9-27CC-4F27-A8C6-4351112AC9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98080" y="109080"/>
            <a:ext cx="5380200" cy="44604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ctr">
            <a:noAutofit/>
          </a:bodyPr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98080" y="631800"/>
            <a:ext cx="5380200" cy="178128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rmAutofit fontScale="81000"/>
          </a:bodyPr>
          <a:p>
            <a:pPr marL="145080" indent="-145080">
              <a:spcBef>
                <a:spcPts val="425"/>
              </a:spcBef>
              <a:buClr>
                <a:srgbClr val="000000"/>
              </a:buClr>
              <a:buFont typeface="Arial"/>
              <a:buChar char="•"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lvl="1" marL="313560" indent="-120960">
              <a:spcBef>
                <a:spcPts val="425"/>
              </a:spcBef>
              <a:buClr>
                <a:srgbClr val="000000"/>
              </a:buClr>
              <a:buFont typeface="Arial"/>
              <a:buChar char="–"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lvl="2" marL="483120" indent="-96480">
              <a:spcBef>
                <a:spcPts val="425"/>
              </a:spcBef>
              <a:buClr>
                <a:srgbClr val="000000"/>
              </a:buClr>
              <a:buFont typeface="Arial"/>
              <a:buChar char="•"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lvl="3" marL="676440" indent="-96480">
              <a:spcBef>
                <a:spcPts val="425"/>
              </a:spcBef>
              <a:buClr>
                <a:srgbClr val="000000"/>
              </a:buClr>
              <a:buFont typeface="Arial"/>
              <a:buChar char="–"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lvl="4" marL="870120" indent="-97560">
              <a:spcBef>
                <a:spcPts val="425"/>
              </a:spcBef>
              <a:buClr>
                <a:srgbClr val="000000"/>
              </a:buClr>
              <a:buFont typeface="Arial"/>
              <a:buChar char="»"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lvl="5" marL="870120" indent="-97560">
              <a:spcBef>
                <a:spcPts val="425"/>
              </a:spcBef>
              <a:buClr>
                <a:srgbClr val="000000"/>
              </a:buClr>
              <a:buFont typeface="Arial"/>
              <a:buChar char="»"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lvl="6" marL="870120" indent="-97560">
              <a:spcBef>
                <a:spcPts val="425"/>
              </a:spcBef>
              <a:buClr>
                <a:srgbClr val="000000"/>
              </a:buClr>
              <a:buFont typeface="Arial"/>
              <a:buChar char="»"/>
              <a:tabLst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98440" y="2459160"/>
            <a:ext cx="1395360" cy="1872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Autofit/>
          </a:bodyPr>
          <a:lstStyle>
            <a:lvl1pPr indent="0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  <a:defRPr b="0" lang="en-US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43000" y="2459160"/>
            <a:ext cx="1890720" cy="1872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Autofit/>
          </a:bodyPr>
          <a:lstStyle>
            <a:lvl1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  <a:defRPr b="0" lang="en-US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282560" y="2459160"/>
            <a:ext cx="1395720" cy="187200"/>
          </a:xfrm>
          <a:prstGeom prst="rect">
            <a:avLst/>
          </a:prstGeom>
          <a:noFill/>
          <a:ln w="0">
            <a:noFill/>
          </a:ln>
        </p:spPr>
        <p:txBody>
          <a:bodyPr lIns="47880" rIns="47880" tIns="23760" bIns="23760" anchor="t">
            <a:noAutofit/>
          </a:bodyPr>
          <a:lstStyle>
            <a:lvl1pPr indent="0" algn="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  <a:defRPr b="0" lang="en-US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77720"/>
                <a:tab algn="l" pos="955800"/>
                <a:tab algn="l" pos="1433520"/>
                <a:tab algn="l" pos="1911240"/>
                <a:tab algn="l" pos="2389320"/>
                <a:tab algn="l" pos="2867040"/>
                <a:tab algn="l" pos="3344760"/>
                <a:tab algn="l" pos="3822840"/>
                <a:tab algn="l" pos="4300560"/>
                <a:tab algn="l" pos="4778280"/>
                <a:tab algn="l" pos="5256360"/>
                <a:tab algn="l" pos="5734080"/>
                <a:tab algn="l" pos="6211800"/>
                <a:tab algn="l" pos="6689880"/>
                <a:tab algn="l" pos="7167600"/>
                <a:tab algn="l" pos="7645320"/>
                <a:tab algn="l" pos="8123400"/>
                <a:tab algn="l" pos="8601120"/>
                <a:tab algn="l" pos="9078840"/>
                <a:tab algn="l" pos="9556920"/>
              </a:tabLst>
            </a:pPr>
            <a:fld id="{9DAC415A-B8FA-4188-8828-BA59F80C9B06}" type="slidenum">
              <a:rPr b="0" lang="en-US" sz="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71520" y="1733400"/>
            <a:ext cx="1697040" cy="37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9640" rIns="89640" tIns="44640" bIns="4464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08000" y="-88920"/>
            <a:ext cx="5761080" cy="2663640"/>
            <a:chOff x="108000" y="-88920"/>
            <a:chExt cx="5761080" cy="2663640"/>
          </a:xfrm>
        </p:grpSpPr>
        <p:sp>
          <p:nvSpPr>
            <p:cNvPr id="43" name=""/>
            <p:cNvSpPr/>
            <p:nvPr/>
          </p:nvSpPr>
          <p:spPr>
            <a:xfrm>
              <a:off x="324000" y="874080"/>
              <a:ext cx="2160720" cy="1437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educ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employment stat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household incom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692360" y="-88920"/>
              <a:ext cx="2519280" cy="129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elf-reporte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sychological distress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de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insomn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stre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476360" y="132840"/>
              <a:ext cx="2089440" cy="1331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08000" y="1466280"/>
              <a:ext cx="1871640" cy="10364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635640" y="1391400"/>
              <a:ext cx="2233440" cy="96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orta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unnatural (suicide, accidents   and violence, alcohol-related)   morta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CHD (coronary heart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isease) morta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276720" y="1169280"/>
              <a:ext cx="2592360" cy="14054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979640" y="1983600"/>
              <a:ext cx="129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flipV="1">
              <a:off x="1403640" y="1317960"/>
              <a:ext cx="360360" cy="14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203640" y="1317960"/>
              <a:ext cx="289080" cy="14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14T08:46:50Z</dcterms:created>
  <dc:creator>ktah</dc:creator>
  <dc:description/>
  <dc:language>en-US</dc:language>
  <cp:lastModifiedBy>ktah</cp:lastModifiedBy>
  <dcterms:modified xsi:type="dcterms:W3CDTF">2010-11-01T15:02:24Z</dcterms:modified>
  <cp:revision>17</cp:revision>
  <dc:subject/>
  <dc:title>Slide 1</dc:title>
</cp:coreProperties>
</file>